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28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microsoft.com/office/2007/relationships/hdphoto" Target="../media/hdphoto1.wdp"/><Relationship Id="rId7" Type="http://schemas.openxmlformats.org/officeDocument/2006/relationships/image" Target="../media/image5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ssociation of intrapatient tacrolimus variability and concentration-to-dose ratio with outcomes in pediatric kidney transplanta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Evaluation of the predictive value of high TacIPV and low C/D ratio for allograft rejec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Baghai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Arassi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High TacIPV is a risk factor for allograft rejection &gt; 12 months post-transplant, and low early C/D ratio is a risk factor for allograft rejection 6 – 12 months post-transplant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4DF9DA5-874F-65E7-368D-B0398EACB24D}"/>
              </a:ext>
            </a:extLst>
          </p:cNvPr>
          <p:cNvSpPr/>
          <p:nvPr/>
        </p:nvSpPr>
        <p:spPr>
          <a:xfrm>
            <a:off x="2511433" y="2255218"/>
            <a:ext cx="497584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solidFill>
                  <a:srgbClr val="004277"/>
                </a:solidFill>
              </a:rPr>
              <a:t>Retrospective multicenter longitudinal study 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EEA0A19-2A1A-A0EA-D028-00E6F44298A7}"/>
              </a:ext>
            </a:extLst>
          </p:cNvPr>
          <p:cNvGrpSpPr/>
          <p:nvPr/>
        </p:nvGrpSpPr>
        <p:grpSpPr>
          <a:xfrm>
            <a:off x="120469" y="2760383"/>
            <a:ext cx="2059317" cy="1553570"/>
            <a:chOff x="54186" y="2738207"/>
            <a:chExt cx="2059317" cy="1553570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DD72BD3-7306-8B92-ACB8-2E06FA71DAC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1540" y="2738207"/>
              <a:ext cx="1188000" cy="731854"/>
              <a:chOff x="715078" y="2845740"/>
              <a:chExt cx="1414431" cy="87134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257105B-6420-D152-FB63-1BC873CC16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9942" b="89766" l="10000" r="91538">
                            <a14:foregroundMark x1="27436" y1="28070" x2="27436" y2="28070"/>
                            <a14:foregroundMark x1="70000" y1="50292" x2="70000" y2="50292"/>
                            <a14:foregroundMark x1="91538" y1="35673" x2="91538" y2="35673"/>
                            <a14:foregroundMark x1="72051" y1="23392" x2="72051" y2="23392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5078" y="2845740"/>
                <a:ext cx="974114" cy="854225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92A47953-ADA1-992D-62FD-836918BBA2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ackgroundRemoval t="9942" b="89766" l="10000" r="91538">
                            <a14:foregroundMark x1="27436" y1="28070" x2="27436" y2="28070"/>
                            <a14:foregroundMark x1="70000" y1="50292" x2="70000" y2="50292"/>
                            <a14:foregroundMark x1="91538" y1="35673" x2="91538" y2="35673"/>
                            <a14:foregroundMark x1="72051" y1="23392" x2="72051" y2="23392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6795"/>
              <a:stretch/>
            </p:blipFill>
            <p:spPr>
              <a:xfrm>
                <a:off x="1611229" y="2862858"/>
                <a:ext cx="518280" cy="854224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1DA666E-C05C-C39D-1DC2-4B36BA60EEE0}"/>
                </a:ext>
              </a:extLst>
            </p:cNvPr>
            <p:cNvSpPr txBox="1"/>
            <p:nvPr/>
          </p:nvSpPr>
          <p:spPr>
            <a:xfrm>
              <a:off x="54186" y="3430003"/>
              <a:ext cx="2059317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rgbClr val="004277"/>
                  </a:solidFill>
                </a:rPr>
                <a:t>N=255 </a:t>
              </a:r>
            </a:p>
            <a:p>
              <a:pPr algn="ctr"/>
              <a:r>
                <a:rPr lang="en-US" sz="1600" b="1" dirty="0">
                  <a:solidFill>
                    <a:srgbClr val="004277"/>
                  </a:solidFill>
                </a:rPr>
                <a:t>Tacrolimus-based immunosuppression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DE406EF6-8D6D-4532-663E-AF695563F357}"/>
              </a:ext>
            </a:extLst>
          </p:cNvPr>
          <p:cNvSpPr txBox="1"/>
          <p:nvPr/>
        </p:nvSpPr>
        <p:spPr>
          <a:xfrm>
            <a:off x="5299864" y="488842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D7F0C78F-BE95-7857-8DA1-68BCE72C5F0F}"/>
              </a:ext>
            </a:extLst>
          </p:cNvPr>
          <p:cNvGrpSpPr/>
          <p:nvPr/>
        </p:nvGrpSpPr>
        <p:grpSpPr>
          <a:xfrm>
            <a:off x="1965227" y="4557641"/>
            <a:ext cx="6098440" cy="734945"/>
            <a:chOff x="2871567" y="3023911"/>
            <a:chExt cx="7274040" cy="915995"/>
          </a:xfrm>
        </p:grpSpPr>
        <p:pic>
          <p:nvPicPr>
            <p:cNvPr id="11" name="Graphic 10" descr="High voltage">
              <a:extLst>
                <a:ext uri="{FF2B5EF4-FFF2-40B4-BE49-F238E27FC236}">
                  <a16:creationId xmlns:a16="http://schemas.microsoft.com/office/drawing/2014/main" id="{9ED4BD6F-1225-4A85-A2FE-370135C4B32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2871567" y="3110427"/>
              <a:ext cx="651498" cy="651498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75C6039-5683-EF7C-3DC1-34DDA95CBDBD}"/>
                </a:ext>
              </a:extLst>
            </p:cNvPr>
            <p:cNvSpPr txBox="1"/>
            <p:nvPr/>
          </p:nvSpPr>
          <p:spPr>
            <a:xfrm>
              <a:off x="3737909" y="3023911"/>
              <a:ext cx="6407698" cy="915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b="1" dirty="0">
                  <a:solidFill>
                    <a:srgbClr val="AA0065"/>
                  </a:solidFill>
                </a:rPr>
                <a:t>TacIPV &gt; 23% 		</a:t>
              </a:r>
              <a:r>
                <a:rPr lang="en-US" b="1" i="0" dirty="0">
                  <a:solidFill>
                    <a:srgbClr val="AA0065"/>
                  </a:solidFill>
                </a:rPr>
                <a:t>↑ rejection &gt; 12 months</a:t>
              </a:r>
              <a:endParaRPr lang="en-US" b="1" dirty="0">
                <a:solidFill>
                  <a:srgbClr val="AA0065"/>
                </a:solidFill>
              </a:endParaRPr>
            </a:p>
            <a:p>
              <a:pPr>
                <a:lnSpc>
                  <a:spcPct val="120000"/>
                </a:lnSpc>
              </a:pPr>
              <a:r>
                <a:rPr lang="en-US" b="1" dirty="0">
                  <a:solidFill>
                    <a:srgbClr val="AA0065"/>
                  </a:solidFill>
                </a:rPr>
                <a:t>Early C/D ratio &lt; 1.0	</a:t>
              </a:r>
              <a:r>
                <a:rPr lang="en-US" b="1" i="0" dirty="0">
                  <a:solidFill>
                    <a:srgbClr val="AA0065"/>
                  </a:solidFill>
                </a:rPr>
                <a:t>↑ rejection  6-12 months</a:t>
              </a:r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B0C4DC2A-5A41-B5F3-90A8-E982E799EF6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53"/>
          <a:stretch/>
        </p:blipFill>
        <p:spPr>
          <a:xfrm>
            <a:off x="2362610" y="2824606"/>
            <a:ext cx="6030000" cy="148934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D38C093-2B41-449A-DA7A-A211CCA4E42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581"/>
          <a:stretch/>
        </p:blipFill>
        <p:spPr>
          <a:xfrm>
            <a:off x="8866630" y="1813816"/>
            <a:ext cx="2734859" cy="3626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1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06-17T00:05:06Z</dcterms:modified>
</cp:coreProperties>
</file>